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340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14430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35433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139895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012073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436479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89596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465934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094897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686139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5591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603731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71689-6D0E-496F-B863-5DDB64C8154F}" type="datetimeFigureOut">
              <a:rPr lang="en-AU" smtClean="0"/>
              <a:t>1/08/2015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ED885-5C9F-4479-94F1-A2A1C3A2410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54037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26" Type="http://schemas.openxmlformats.org/officeDocument/2006/relationships/image" Target="../media/image14.png"/><Relationship Id="rId39" Type="http://schemas.microsoft.com/office/2007/relationships/hdphoto" Target="../media/hdphoto18.wdp"/><Relationship Id="rId3" Type="http://schemas.openxmlformats.org/officeDocument/2006/relationships/image" Target="../media/image2.png"/><Relationship Id="rId21" Type="http://schemas.microsoft.com/office/2007/relationships/hdphoto" Target="../media/hdphoto9.wdp"/><Relationship Id="rId34" Type="http://schemas.openxmlformats.org/officeDocument/2006/relationships/image" Target="../media/image18.jpeg"/><Relationship Id="rId42" Type="http://schemas.openxmlformats.org/officeDocument/2006/relationships/image" Target="../media/image22.png"/><Relationship Id="rId47" Type="http://schemas.microsoft.com/office/2007/relationships/hdphoto" Target="../media/hdphoto22.wdp"/><Relationship Id="rId50" Type="http://schemas.openxmlformats.org/officeDocument/2006/relationships/image" Target="../media/image26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microsoft.com/office/2007/relationships/hdphoto" Target="../media/hdphoto11.wdp"/><Relationship Id="rId33" Type="http://schemas.microsoft.com/office/2007/relationships/hdphoto" Target="../media/hdphoto15.wdp"/><Relationship Id="rId38" Type="http://schemas.openxmlformats.org/officeDocument/2006/relationships/image" Target="../media/image20.jpeg"/><Relationship Id="rId46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29" Type="http://schemas.microsoft.com/office/2007/relationships/hdphoto" Target="../media/hdphoto13.wdp"/><Relationship Id="rId41" Type="http://schemas.microsoft.com/office/2007/relationships/hdphoto" Target="../media/hdphoto19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24" Type="http://schemas.openxmlformats.org/officeDocument/2006/relationships/image" Target="../media/image13.png"/><Relationship Id="rId32" Type="http://schemas.openxmlformats.org/officeDocument/2006/relationships/image" Target="../media/image17.png"/><Relationship Id="rId37" Type="http://schemas.microsoft.com/office/2007/relationships/hdphoto" Target="../media/hdphoto17.wdp"/><Relationship Id="rId40" Type="http://schemas.openxmlformats.org/officeDocument/2006/relationships/image" Target="../media/image21.png"/><Relationship Id="rId45" Type="http://schemas.microsoft.com/office/2007/relationships/hdphoto" Target="../media/hdphoto21.wdp"/><Relationship Id="rId5" Type="http://schemas.microsoft.com/office/2007/relationships/hdphoto" Target="../media/hdphoto1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5.png"/><Relationship Id="rId36" Type="http://schemas.openxmlformats.org/officeDocument/2006/relationships/image" Target="../media/image19.jpeg"/><Relationship Id="rId49" Type="http://schemas.microsoft.com/office/2007/relationships/hdphoto" Target="../media/hdphoto23.wdp"/><Relationship Id="rId10" Type="http://schemas.openxmlformats.org/officeDocument/2006/relationships/image" Target="../media/image6.png"/><Relationship Id="rId19" Type="http://schemas.microsoft.com/office/2007/relationships/hdphoto" Target="../media/hdphoto8.wdp"/><Relationship Id="rId31" Type="http://schemas.microsoft.com/office/2007/relationships/hdphoto" Target="../media/hdphoto14.wdp"/><Relationship Id="rId44" Type="http://schemas.openxmlformats.org/officeDocument/2006/relationships/image" Target="../media/image23.png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8.png"/><Relationship Id="rId22" Type="http://schemas.openxmlformats.org/officeDocument/2006/relationships/image" Target="../media/image12.jpeg"/><Relationship Id="rId27" Type="http://schemas.microsoft.com/office/2007/relationships/hdphoto" Target="../media/hdphoto12.wdp"/><Relationship Id="rId30" Type="http://schemas.openxmlformats.org/officeDocument/2006/relationships/image" Target="../media/image16.png"/><Relationship Id="rId35" Type="http://schemas.microsoft.com/office/2007/relationships/hdphoto" Target="../media/hdphoto16.wdp"/><Relationship Id="rId43" Type="http://schemas.microsoft.com/office/2007/relationships/hdphoto" Target="../media/hdphoto20.wdp"/><Relationship Id="rId48" Type="http://schemas.openxmlformats.org/officeDocument/2006/relationships/image" Target="../media/image25.png"/><Relationship Id="rId8" Type="http://schemas.openxmlformats.org/officeDocument/2006/relationships/image" Target="../media/image5.png"/><Relationship Id="rId51" Type="http://schemas.microsoft.com/office/2007/relationships/hdphoto" Target="../media/hdphoto2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1245" y="3116892"/>
            <a:ext cx="1171971" cy="174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9854" y="3145328"/>
            <a:ext cx="1140905" cy="1696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35"/>
          <p:cNvSpPr txBox="1">
            <a:spLocks noChangeArrowheads="1"/>
          </p:cNvSpPr>
          <p:nvPr/>
        </p:nvSpPr>
        <p:spPr bwMode="auto">
          <a:xfrm>
            <a:off x="-16909" y="150080"/>
            <a:ext cx="2905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A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6" name="TextBox 35"/>
          <p:cNvSpPr txBox="1">
            <a:spLocks noChangeArrowheads="1"/>
          </p:cNvSpPr>
          <p:nvPr/>
        </p:nvSpPr>
        <p:spPr bwMode="auto">
          <a:xfrm>
            <a:off x="8685" y="2958392"/>
            <a:ext cx="2905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B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48680" y="3030400"/>
            <a:ext cx="3002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+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fl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l/fl</a:t>
            </a:r>
            <a:endParaRPr lang="en-AU" sz="1000" b="1" i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9628" y="202048"/>
            <a:ext cx="30840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+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fl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l/fl</a:t>
            </a:r>
            <a:endParaRPr lang="en-AU" sz="1000" b="1" i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3" name="Picture 12" descr="C:\Users\Helen\Documents\Humbert\Publications\G&amp;D Scrib skin paper\Skin DATA\IHC\gH2AX - short term\g-H2AX\2979-10\Image1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363733" y="3226090"/>
            <a:ext cx="1077222" cy="7540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3" descr="C:\Users\Helen\Documents\Humbert\Publications\G&amp;D Scrib skin paper\Skin DATA\IHC\gH2AX - short term\g-H2AX\2363-10\Image1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1478747" y="3226003"/>
            <a:ext cx="1067519" cy="754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14" descr="C:\Users\Helen\Documents\Humbert\Publications\G&amp;D Scrib skin paper\Skin DATA\IHC\gH2AX - short term\g-H2AX\2973-10\Image1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saturation sat="66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2583457" y="3226086"/>
            <a:ext cx="1067514" cy="7540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5" descr="C:\Users\Helen\Documents\Humbert\Publications\G&amp;D Scrib skin paper\Skin DATA\IHC\gH2AX - short term\g-H2AX\970-10\Image5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2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63733" y="4025040"/>
            <a:ext cx="1067121" cy="7540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16" descr="C:\Users\Helen\Documents\Humbert\Publications\G&amp;D Scrib skin paper\Skin DATA\IHC\gH2AX - short term\g-H2AX\976-10\Image6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50000"/>
                    </a14:imgEffect>
                    <a14:imgEffect>
                      <a14:brightnessContrast brigh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1478746" y="4025035"/>
            <a:ext cx="1067520" cy="7540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7" descr="C:\Users\Helen\Documents\Humbert\Publications\G&amp;D Scrib skin paper\Skin DATA\IHC\gH2AX - short term\g-H2AX\985-10\Image3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583457" y="4025040"/>
            <a:ext cx="1067514" cy="7540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8" descr="C:\Users\Helen\Documents\Humbert\Publications\G&amp;D Scrib skin paper\Skin DATA\IHC\gH2AX - short term\g-H2AX\2365-10\Image6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63733" y="4814175"/>
            <a:ext cx="1067121" cy="7540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9" descr="C:\Users\Helen\Documents\Humbert\Publications\G&amp;D Scrib skin paper\Skin DATA\IHC\gH2AX - short term\g-H2AX\1876-10\Image6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1478749" y="4814175"/>
            <a:ext cx="1067518" cy="7540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20" descr="C:\Users\Helen\Documents\Humbert\Publications\G&amp;D Scrib skin paper\Skin DATA\IHC\gH2AX - short term\g-H2AX\2370-10\Image4.tif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583456" y="4814175"/>
            <a:ext cx="1067516" cy="7540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Line 8"/>
          <p:cNvSpPr>
            <a:spLocks noChangeShapeType="1"/>
          </p:cNvSpPr>
          <p:nvPr/>
        </p:nvSpPr>
        <p:spPr bwMode="auto">
          <a:xfrm>
            <a:off x="1036451" y="3909600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39" name="Line 8"/>
          <p:cNvSpPr>
            <a:spLocks noChangeShapeType="1"/>
          </p:cNvSpPr>
          <p:nvPr/>
        </p:nvSpPr>
        <p:spPr bwMode="auto">
          <a:xfrm>
            <a:off x="2156791" y="3909600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0" name="Line 8"/>
          <p:cNvSpPr>
            <a:spLocks noChangeShapeType="1"/>
          </p:cNvSpPr>
          <p:nvPr/>
        </p:nvSpPr>
        <p:spPr bwMode="auto">
          <a:xfrm>
            <a:off x="3248227" y="3909600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1" name="Line 8"/>
          <p:cNvSpPr>
            <a:spLocks noChangeShapeType="1"/>
          </p:cNvSpPr>
          <p:nvPr/>
        </p:nvSpPr>
        <p:spPr bwMode="auto">
          <a:xfrm>
            <a:off x="1036451" y="469360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2" name="Line 8"/>
          <p:cNvSpPr>
            <a:spLocks noChangeShapeType="1"/>
          </p:cNvSpPr>
          <p:nvPr/>
        </p:nvSpPr>
        <p:spPr bwMode="auto">
          <a:xfrm>
            <a:off x="2156791" y="469360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3" name="Line 8"/>
          <p:cNvSpPr>
            <a:spLocks noChangeShapeType="1"/>
          </p:cNvSpPr>
          <p:nvPr/>
        </p:nvSpPr>
        <p:spPr bwMode="auto">
          <a:xfrm>
            <a:off x="3248227" y="469360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4" name="Line 8"/>
          <p:cNvSpPr>
            <a:spLocks noChangeShapeType="1"/>
          </p:cNvSpPr>
          <p:nvPr/>
        </p:nvSpPr>
        <p:spPr bwMode="auto">
          <a:xfrm>
            <a:off x="1019278" y="550596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5" name="Line 8"/>
          <p:cNvSpPr>
            <a:spLocks noChangeShapeType="1"/>
          </p:cNvSpPr>
          <p:nvPr/>
        </p:nvSpPr>
        <p:spPr bwMode="auto">
          <a:xfrm>
            <a:off x="2139618" y="550596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46" name="Line 8"/>
          <p:cNvSpPr>
            <a:spLocks noChangeShapeType="1"/>
          </p:cNvSpPr>
          <p:nvPr/>
        </p:nvSpPr>
        <p:spPr bwMode="auto">
          <a:xfrm>
            <a:off x="3231054" y="550596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pic>
        <p:nvPicPr>
          <p:cNvPr id="47" name="Picture 22" descr="C:\Users\Helen\Documents\Humbert\Publications\G&amp;D Scrib skin paper\Skin DATA\IHC\CC3 short term\cl casp 3 short-term\970-10\Image3.tif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94991" y="1206183"/>
            <a:ext cx="1067514" cy="7584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23" descr="C:\Users\Helen\Documents\Humbert\Publications\G&amp;D Scrib skin paper\Skin DATA\IHC\CC3 short term\cl casp 3 short-term\1875-10\Image1.tif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95754" y="2017935"/>
            <a:ext cx="1069075" cy="7584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24" descr="C:\Users\Helen\Documents\Humbert\Publications\G&amp;D Scrib skin paper\Skin DATA\IHC\CC3 short term\cl casp 3 short-term\2365-10\Image1.tif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94990" y="2017935"/>
            <a:ext cx="1067515" cy="7584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25" descr="C:\Users\Helen\Documents\Humbert\Publications\G&amp;D Scrib skin paper\Skin DATA\IHC\CC3 short term\cl casp 3 short-term\2975-10\2975-10.tif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50000"/>
                    </a14:imgEffect>
                    <a14:imgEffect>
                      <a14:brightnessContrast brigh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95758" y="1206182"/>
            <a:ext cx="1069071" cy="7584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26" descr="C:\Users\Helen\Documents\Humbert\Publications\G&amp;D Scrib skin paper\Skin DATA\IHC\CC3 short term\cl casp 3 short-term\974-10.tif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2496615" y="1206183"/>
            <a:ext cx="1077045" cy="7584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7" descr="C:\Users\Helen\Documents\Humbert\Publications\G&amp;D Scrib skin paper\Skin DATA\IHC\CC3 short term\cl casp 3 short-term\2362-10.tif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2496608" y="2017935"/>
            <a:ext cx="1077049" cy="7584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28" descr="C:\Users\Helen\Documents\Humbert\Publications\G&amp;D Scrib skin paper\Skin DATA\IHC\CC3 short term\cl casp 3 short-term\2979-10.tif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294991" y="400944"/>
            <a:ext cx="1067514" cy="7538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29" descr="C:\Users\Helen\Documents\Humbert\Publications\G&amp;D Scrib skin paper\Skin DATA\IHC\CC3 short term\cl casp 3 short-term\2367-10b.tif"/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95759" y="400944"/>
            <a:ext cx="1069070" cy="7491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30" descr="C:\Users\Helen\Documents\Humbert\Publications\G&amp;D Scrib skin paper\Skin DATA\IHC\CC3 short term\cl casp 3 short-term\2973-10.tif"/>
          <p:cNvPicPr>
            <a:picLocks noChangeAspect="1" noChangeArrowheads="1"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6200000">
            <a:off x="2658225" y="247330"/>
            <a:ext cx="753821" cy="1077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6" name="Line 8"/>
          <p:cNvSpPr>
            <a:spLocks noChangeShapeType="1"/>
          </p:cNvSpPr>
          <p:nvPr/>
        </p:nvSpPr>
        <p:spPr bwMode="auto">
          <a:xfrm>
            <a:off x="966274" y="108182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57" name="Line 8"/>
          <p:cNvSpPr>
            <a:spLocks noChangeShapeType="1"/>
          </p:cNvSpPr>
          <p:nvPr/>
        </p:nvSpPr>
        <p:spPr bwMode="auto">
          <a:xfrm>
            <a:off x="2079618" y="108182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58" name="Line 8"/>
          <p:cNvSpPr>
            <a:spLocks noChangeShapeType="1"/>
          </p:cNvSpPr>
          <p:nvPr/>
        </p:nvSpPr>
        <p:spPr bwMode="auto">
          <a:xfrm>
            <a:off x="3178050" y="1081828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59" name="Line 8"/>
          <p:cNvSpPr>
            <a:spLocks noChangeShapeType="1"/>
          </p:cNvSpPr>
          <p:nvPr/>
        </p:nvSpPr>
        <p:spPr bwMode="auto">
          <a:xfrm>
            <a:off x="966274" y="1888799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60" name="Line 8"/>
          <p:cNvSpPr>
            <a:spLocks noChangeShapeType="1"/>
          </p:cNvSpPr>
          <p:nvPr/>
        </p:nvSpPr>
        <p:spPr bwMode="auto">
          <a:xfrm>
            <a:off x="2079618" y="1888799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61" name="Line 8"/>
          <p:cNvSpPr>
            <a:spLocks noChangeShapeType="1"/>
          </p:cNvSpPr>
          <p:nvPr/>
        </p:nvSpPr>
        <p:spPr bwMode="auto">
          <a:xfrm>
            <a:off x="3178050" y="1888799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62" name="Line 8"/>
          <p:cNvSpPr>
            <a:spLocks noChangeShapeType="1"/>
          </p:cNvSpPr>
          <p:nvPr/>
        </p:nvSpPr>
        <p:spPr bwMode="auto">
          <a:xfrm>
            <a:off x="966274" y="2708183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63" name="Line 8"/>
          <p:cNvSpPr>
            <a:spLocks noChangeShapeType="1"/>
          </p:cNvSpPr>
          <p:nvPr/>
        </p:nvSpPr>
        <p:spPr bwMode="auto">
          <a:xfrm>
            <a:off x="2079618" y="2708183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64" name="Line 8"/>
          <p:cNvSpPr>
            <a:spLocks noChangeShapeType="1"/>
          </p:cNvSpPr>
          <p:nvPr/>
        </p:nvSpPr>
        <p:spPr bwMode="auto">
          <a:xfrm>
            <a:off x="3178050" y="2708183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65" name="TextBox 64"/>
          <p:cNvSpPr txBox="1"/>
          <p:nvPr/>
        </p:nvSpPr>
        <p:spPr>
          <a:xfrm rot="16200000">
            <a:off x="-858981" y="4145038"/>
            <a:ext cx="2274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PA             DMBA          Acetone</a:t>
            </a:r>
          </a:p>
        </p:txBody>
      </p:sp>
      <p:sp>
        <p:nvSpPr>
          <p:cNvPr id="66" name="TextBox 65"/>
          <p:cNvSpPr txBox="1"/>
          <p:nvPr/>
        </p:nvSpPr>
        <p:spPr>
          <a:xfrm rot="16200000">
            <a:off x="-908959" y="1338703"/>
            <a:ext cx="2274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PA              DMBA          Acetone</a:t>
            </a:r>
          </a:p>
        </p:txBody>
      </p:sp>
      <p:pic>
        <p:nvPicPr>
          <p:cNvPr id="67" name="Picture 10" descr="T:\Phillips\Lab Shared\Helen\Publications\Scrib skin paper\IF\p53\het\1330\Image2.tif"/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sharpenSoften amount="14000"/>
                    </a14:imgEffect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4304767" y="1199103"/>
            <a:ext cx="1075626" cy="7540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8" name="Picture 6" descr="T:\Phillips\Lab Shared\Helen\Publications\Scrib skin paper\IHC\p21\4\Het\1329-10\Image8.tif"/>
          <p:cNvPicPr>
            <a:picLocks noChangeAspect="1" noChangeArrowheads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sharpenSoften amount="50000"/>
                    </a14:imgEffect>
                    <a14:imgEffect>
                      <a14:brightnessContrast brigh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5400000">
            <a:off x="5578139" y="1037751"/>
            <a:ext cx="746557" cy="1075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9" name="TextBox 35"/>
          <p:cNvSpPr txBox="1">
            <a:spLocks noChangeArrowheads="1"/>
          </p:cNvSpPr>
          <p:nvPr/>
        </p:nvSpPr>
        <p:spPr bwMode="auto">
          <a:xfrm>
            <a:off x="3871840" y="144215"/>
            <a:ext cx="2905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C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703833" y="187250"/>
            <a:ext cx="18141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p53                        p21</a:t>
            </a:r>
          </a:p>
        </p:txBody>
      </p:sp>
      <p:pic>
        <p:nvPicPr>
          <p:cNvPr id="72" name="Picture 2" descr="T:\Phillips\Lab Shared\Helen\Publications\Scrib skin paper\IF\p53\wt\1322\New Folder\Image4.tif"/>
          <p:cNvPicPr>
            <a:picLocks noChangeAspect="1" noChangeArrowheads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sharpenSoften amount="14000"/>
                    </a14:imgEffect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6200000" flipH="1">
            <a:off x="4461960" y="244261"/>
            <a:ext cx="754063" cy="10684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3" name="Line 8"/>
          <p:cNvSpPr>
            <a:spLocks noChangeShapeType="1"/>
          </p:cNvSpPr>
          <p:nvPr/>
        </p:nvSpPr>
        <p:spPr bwMode="auto">
          <a:xfrm>
            <a:off x="4945342" y="1076696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74" name="Line 8"/>
          <p:cNvSpPr>
            <a:spLocks noChangeShapeType="1"/>
          </p:cNvSpPr>
          <p:nvPr/>
        </p:nvSpPr>
        <p:spPr bwMode="auto">
          <a:xfrm>
            <a:off x="4975044" y="1887539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pic>
        <p:nvPicPr>
          <p:cNvPr id="75" name="Picture 11" descr="T:\Phillips\Lab Shared\Helen\Publications\Scrib skin paper\IF\p53\hom\1324\Image6.tif"/>
          <p:cNvPicPr>
            <a:picLocks noChangeAspect="1" noChangeArrowheads="1"/>
          </p:cNvPicPr>
          <p:nvPr/>
        </p:nvPicPr>
        <p:blipFill rotWithShape="1"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sharpenSoften amount="14000"/>
                    </a14:imgEffect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5400000">
            <a:off x="4480769" y="1855461"/>
            <a:ext cx="758470" cy="1075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6" name="Line 8"/>
          <p:cNvSpPr>
            <a:spLocks noChangeShapeType="1"/>
          </p:cNvSpPr>
          <p:nvPr/>
        </p:nvSpPr>
        <p:spPr bwMode="auto">
          <a:xfrm>
            <a:off x="5006337" y="2716627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pic>
        <p:nvPicPr>
          <p:cNvPr id="77" name="Picture 5" descr="T:\Phillips\Lab Shared\Helen\Publications\Scrib skin paper\IHC\p21\4\WT\Image6.tif"/>
          <p:cNvPicPr>
            <a:picLocks noChangeAspect="1" noChangeArrowheads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5397817" y="404038"/>
            <a:ext cx="1086700" cy="7540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Line 8"/>
          <p:cNvSpPr>
            <a:spLocks noChangeShapeType="1"/>
          </p:cNvSpPr>
          <p:nvPr/>
        </p:nvSpPr>
        <p:spPr bwMode="auto">
          <a:xfrm>
            <a:off x="6088860" y="1082524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pic>
        <p:nvPicPr>
          <p:cNvPr id="79" name="Picture 8" descr="T:\Phillips\Lab Shared\Helen\Publications\Scrib skin paper\IHC\p21\4\HOM\1872-10\Image3.tif"/>
          <p:cNvPicPr>
            <a:picLocks noChangeAspect="1" noChangeArrowheads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sharpenSoften amount="50000"/>
                    </a14:imgEffect>
                    <a14:imgEffect>
                      <a14:brightnessContrast bright="-4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426679" y="2014034"/>
            <a:ext cx="1075627" cy="7584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0" name="Line 8"/>
          <p:cNvSpPr>
            <a:spLocks noChangeShapeType="1"/>
          </p:cNvSpPr>
          <p:nvPr/>
        </p:nvSpPr>
        <p:spPr bwMode="auto">
          <a:xfrm>
            <a:off x="6088860" y="1887539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81" name="Line 8"/>
          <p:cNvSpPr>
            <a:spLocks noChangeShapeType="1"/>
          </p:cNvSpPr>
          <p:nvPr/>
        </p:nvSpPr>
        <p:spPr bwMode="auto">
          <a:xfrm>
            <a:off x="6102489" y="2716627"/>
            <a:ext cx="34172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82" name="TextBox 35"/>
          <p:cNvSpPr txBox="1">
            <a:spLocks noChangeArrowheads="1"/>
          </p:cNvSpPr>
          <p:nvPr/>
        </p:nvSpPr>
        <p:spPr bwMode="auto">
          <a:xfrm>
            <a:off x="4000943" y="2915816"/>
            <a:ext cx="2905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D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83" name="TextBox 35"/>
          <p:cNvSpPr txBox="1">
            <a:spLocks noChangeArrowheads="1"/>
          </p:cNvSpPr>
          <p:nvPr/>
        </p:nvSpPr>
        <p:spPr bwMode="auto">
          <a:xfrm>
            <a:off x="5299402" y="2929476"/>
            <a:ext cx="29051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E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85" name="TextBox 21"/>
          <p:cNvSpPr txBox="1">
            <a:spLocks noChangeArrowheads="1"/>
          </p:cNvSpPr>
          <p:nvPr/>
        </p:nvSpPr>
        <p:spPr bwMode="auto">
          <a:xfrm rot="10800000">
            <a:off x="4065820" y="295478"/>
            <a:ext cx="338554" cy="23873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fl/fl</a:t>
            </a:r>
            <a:r>
              <a:rPr lang="en-AU" altLang="en-US" sz="1000" b="1" i="1" dirty="0">
                <a:latin typeface="Helvetica" pitchFamily="34" charset="0"/>
              </a:rPr>
              <a:t>     </a:t>
            </a:r>
            <a:r>
              <a:rPr lang="en-AU" altLang="en-US" sz="1000" b="1" i="1" dirty="0" smtClean="0">
                <a:latin typeface="Helvetica" pitchFamily="34" charset="0"/>
              </a:rPr>
              <a:t>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fl</a:t>
            </a:r>
            <a:r>
              <a:rPr lang="en-AU" altLang="en-US" sz="1000" b="1" i="1" dirty="0">
                <a:latin typeface="Helvetica" pitchFamily="34" charset="0"/>
              </a:rPr>
              <a:t>  </a:t>
            </a:r>
            <a:r>
              <a:rPr lang="en-AU" altLang="en-US" sz="1000" b="1" i="1" dirty="0" smtClean="0">
                <a:latin typeface="Helvetica" pitchFamily="34" charset="0"/>
              </a:rPr>
              <a:t>         </a:t>
            </a:r>
            <a:r>
              <a:rPr lang="en-AU" altLang="en-US" sz="1000" b="1" i="1" dirty="0">
                <a:latin typeface="Helvetica" pitchFamily="34" charset="0"/>
              </a:rPr>
              <a:t>Scrib</a:t>
            </a:r>
            <a:r>
              <a:rPr lang="en-AU" altLang="en-US" sz="1000" b="1" i="1" baseline="30000" dirty="0">
                <a:latin typeface="Helvetica" pitchFamily="34" charset="0"/>
              </a:rPr>
              <a:t>+/+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28347" y="8604448"/>
            <a:ext cx="29067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S5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740916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1</TotalTime>
  <Words>33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10</cp:revision>
  <dcterms:created xsi:type="dcterms:W3CDTF">2015-07-16T12:35:35Z</dcterms:created>
  <dcterms:modified xsi:type="dcterms:W3CDTF">2015-08-01T01:57:01Z</dcterms:modified>
</cp:coreProperties>
</file>